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329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506" y="-102"/>
      </p:cViewPr>
      <p:guideLst>
        <p:guide orient="horz" pos="215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DE7F0-F906-4EB2-B51F-5CCF5782CCE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5B479-5F63-4FD5-AE56-10B0BD27858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-231775" y="3856355"/>
            <a:ext cx="20339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 Black" panose="020B0A04020102020204" charset="0"/>
                <a:cs typeface="Arial Black" panose="020B0A04020102020204" charset="0"/>
              </a:rPr>
              <a:t>A179L-Georgia/2007</a:t>
            </a:r>
            <a:endParaRPr lang="en-US" altLang="zh-CN" sz="1200">
              <a:latin typeface="Arial Black" panose="020B0A04020102020204" charset="0"/>
              <a:cs typeface="Arial Black" panose="020B0A040201020202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-20955" y="-18415"/>
            <a:ext cx="25133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 Black" panose="020B0A04020102020204" charset="0"/>
                <a:cs typeface="Arial Black" panose="020B0A04020102020204" charset="0"/>
              </a:rPr>
              <a:t>Additional Figure</a:t>
            </a:r>
            <a:endParaRPr lang="en-US" altLang="zh-CN">
              <a:latin typeface="Arial Black" panose="020B0A04020102020204" charset="0"/>
              <a:cs typeface="Arial Black" panose="020B0A040201020202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25095" y="4800600"/>
            <a:ext cx="8964930" cy="21228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p>
            <a:r>
              <a:rPr lang="zh-CN" altLang="en-US" sz="1200">
                <a:latin typeface="Arial Black" panose="020B0A04020102020204" charset="0"/>
                <a:cs typeface="Arial Black" panose="020B0A04020102020204" charset="0"/>
              </a:rPr>
              <a:t>Figure Legends</a:t>
            </a:r>
            <a:endParaRPr lang="zh-CN" altLang="en-US" sz="1200">
              <a:latin typeface="Arial Black" panose="020B0A04020102020204" charset="0"/>
              <a:cs typeface="Arial Black" panose="020B0A04020102020204" charset="0"/>
            </a:endParaRPr>
          </a:p>
          <a:p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The </a:t>
            </a:r>
            <a:r>
              <a:rPr lang="zh-CN" altLang="en-US" sz="1200" b="1">
                <a:latin typeface="Times New Roman" panose="02020603050405020304" charset="0"/>
                <a:cs typeface="Times New Roman" panose="02020603050405020304" charset="0"/>
              </a:rPr>
              <a:t>original, full-length gel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s  for western blot analysis of protein expression at different times after ASFV PEGX-A179L transfection into HEK-293T cells in the Manuscript.(A):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Samples were collected after ASFV A179L from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</a:rPr>
              <a:t>M. domestica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flies transfected for 24 h, 30 h and 36 h, respectively.The expression  levels of ASFV A179L were detected b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stern blot analysis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under the condition of  sample adding 50ug / 15uL and 40 ug /12 uL,respectively;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(B):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Samples were collected after ASFV A179L from  Gerorgia/2007 strains transfected for 24 h, 30 h and 36 h, and the expression of ASFV A179L was detected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b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stern blot analysis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under the condition of  sample adding 50 ug / 15 uL and 40 ug / 12 uL,respectively;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</a:rPr>
              <a:t>(C):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Samples were collected after 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ASFV A179L from </a:t>
            </a:r>
            <a:r>
              <a:rPr lang="en-US" altLang="zh-CN" sz="12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M. domestica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flies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transfection for 24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, 30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30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ectively,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the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ternal parameters( β-actin) displayed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b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stern blot analysis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in the corresponding time period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under the condition of sample adding 50ug / 15uLand 40ug / 12uL, respectively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.(D):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Samples were collected after ASFV A179L from  Gerorgia/2007 strains 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after transfection for 24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, 30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3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6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h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,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respectively,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the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ternal parameters( β-actin) displayed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by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stern blot analysis</a:t>
            </a:r>
            <a:r>
              <a:rPr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in the corresponding time period 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under the condition of sample adding 50ug / 15uL and 40ug / 12uL,respectively.</a:t>
            </a:r>
            <a:endParaRPr 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309880" y="483235"/>
            <a:ext cx="9078595" cy="2050415"/>
            <a:chOff x="1778" y="1631"/>
            <a:chExt cx="14297" cy="3229"/>
          </a:xfrm>
        </p:grpSpPr>
        <p:sp>
          <p:nvSpPr>
            <p:cNvPr id="4" name="文本框 3"/>
            <p:cNvSpPr txBox="1"/>
            <p:nvPr/>
          </p:nvSpPr>
          <p:spPr>
            <a:xfrm>
              <a:off x="14557" y="3651"/>
              <a:ext cx="151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1200">
                  <a:latin typeface="Arial Black" panose="020B0A04020102020204" charset="0"/>
                  <a:cs typeface="Arial Black" panose="020B0A04020102020204" charset="0"/>
                </a:rPr>
                <a:t>β</a:t>
              </a:r>
              <a:r>
                <a:rPr lang="en-US" altLang="zh-CN" sz="1200">
                  <a:latin typeface="Arial Black" panose="020B0A04020102020204" charset="0"/>
                  <a:cs typeface="Arial Black" panose="020B0A04020102020204" charset="0"/>
                </a:rPr>
                <a:t>-actin</a:t>
              </a:r>
              <a:endParaRPr lang="en-US" altLang="zh-CN" sz="1200">
                <a:latin typeface="Arial Black" panose="020B0A04020102020204" charset="0"/>
                <a:cs typeface="Arial Black" panose="020B0A040201020202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778" y="3651"/>
              <a:ext cx="199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>
                  <a:latin typeface="Arial Black" panose="020B0A04020102020204" charset="0"/>
                  <a:cs typeface="Arial Black" panose="020B0A04020102020204" charset="0"/>
                </a:rPr>
                <a:t>A179L-</a:t>
              </a:r>
              <a:r>
                <a:rPr lang="en-US" altLang="zh-CN" sz="1200" i="1">
                  <a:latin typeface="Arial Black" panose="020B0A04020102020204" charset="0"/>
                  <a:cs typeface="Arial Black" panose="020B0A04020102020204" charset="0"/>
                </a:rPr>
                <a:t>M</a:t>
              </a:r>
              <a:r>
                <a:rPr lang="en-US" altLang="zh-CN" sz="1200">
                  <a:latin typeface="Arial Black" panose="020B0A04020102020204" charset="0"/>
                  <a:cs typeface="Arial Black" panose="020B0A04020102020204" charset="0"/>
                </a:rPr>
                <a:t>.Fly</a:t>
              </a:r>
              <a:endParaRPr lang="en-US" altLang="zh-CN" sz="1200">
                <a:latin typeface="Arial Black" panose="020B0A04020102020204" charset="0"/>
                <a:cs typeface="Arial Black" panose="020B0A04020102020204" charset="0"/>
              </a:endParaRPr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3664" y="1631"/>
              <a:ext cx="5380" cy="3229"/>
              <a:chOff x="3770" y="96"/>
              <a:chExt cx="5380" cy="3229"/>
            </a:xfrm>
          </p:grpSpPr>
          <p:grpSp>
            <p:nvGrpSpPr>
              <p:cNvPr id="12" name="组合 11"/>
              <p:cNvGrpSpPr/>
              <p:nvPr/>
            </p:nvGrpSpPr>
            <p:grpSpPr>
              <a:xfrm>
                <a:off x="3770" y="627"/>
                <a:ext cx="5381" cy="2699"/>
                <a:chOff x="4657" y="2836"/>
                <a:chExt cx="4368" cy="2184"/>
              </a:xfrm>
            </p:grpSpPr>
            <p:pic>
              <p:nvPicPr>
                <p:cNvPr id="23" name="图片 22" descr="2018.7.2atg7.2"/>
                <p:cNvPicPr>
                  <a:picLocks noChangeAspect="1"/>
                </p:cNvPicPr>
                <p:nvPr/>
              </p:nvPicPr>
              <p:blipFill>
                <a:blip r:embed="rId1">
                  <a:lum bright="24000" contrast="18000"/>
                </a:blip>
                <a:srcRect l="25241" t="45707" r="20152" b="34249"/>
                <a:stretch>
                  <a:fillRect/>
                </a:stretch>
              </p:blipFill>
              <p:spPr>
                <a:xfrm>
                  <a:off x="4742" y="3071"/>
                  <a:ext cx="4200" cy="1949"/>
                </a:xfrm>
                <a:prstGeom prst="rect">
                  <a:avLst/>
                </a:prstGeom>
              </p:spPr>
            </p:pic>
            <p:sp>
              <p:nvSpPr>
                <p:cNvPr id="10" name="文本框 9"/>
                <p:cNvSpPr txBox="1"/>
                <p:nvPr/>
              </p:nvSpPr>
              <p:spPr>
                <a:xfrm>
                  <a:off x="4657" y="2836"/>
                  <a:ext cx="4368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>
                      <a:latin typeface="Arial Black" panose="020B0A04020102020204" charset="0"/>
                      <a:cs typeface="Arial Black" panose="020B0A04020102020204" charset="0"/>
                    </a:rPr>
                    <a:t>A         </a:t>
                  </a:r>
                  <a:r>
                    <a:rPr lang="en-US" altLang="zh-CN" sz="1000">
                      <a:latin typeface="Arial Black" panose="020B0A04020102020204" charset="0"/>
                      <a:cs typeface="Arial Black" panose="020B0A04020102020204" charset="0"/>
                      <a:sym typeface="+mn-ea"/>
                    </a:rPr>
                    <a:t>24h    30h   36h     24h   30h   36h</a:t>
                  </a:r>
                  <a:r>
                    <a:rPr lang="en-US" altLang="zh-CN" sz="1200">
                      <a:latin typeface="Arial Black" panose="020B0A04020102020204" charset="0"/>
                      <a:cs typeface="Arial Black" panose="020B0A04020102020204" charset="0"/>
                      <a:sym typeface="+mn-ea"/>
                    </a:rPr>
                    <a:t>   </a:t>
                  </a:r>
                  <a:endParaRPr lang="en-US" altLang="zh-CN" sz="1200">
                    <a:latin typeface="Arial Black" panose="020B0A04020102020204" charset="0"/>
                    <a:cs typeface="Arial Black" panose="020B0A04020102020204" charset="0"/>
                  </a:endParaRPr>
                </a:p>
              </p:txBody>
            </p:sp>
          </p:grpSp>
          <p:grpSp>
            <p:nvGrpSpPr>
              <p:cNvPr id="30" name="组合 29"/>
              <p:cNvGrpSpPr/>
              <p:nvPr/>
            </p:nvGrpSpPr>
            <p:grpSpPr>
              <a:xfrm>
                <a:off x="4660" y="96"/>
                <a:ext cx="1798" cy="531"/>
                <a:chOff x="4660" y="96"/>
                <a:chExt cx="1798" cy="531"/>
              </a:xfrm>
            </p:grpSpPr>
            <p:sp>
              <p:nvSpPr>
                <p:cNvPr id="24" name="文本框 23"/>
                <p:cNvSpPr txBox="1"/>
                <p:nvPr/>
              </p:nvSpPr>
              <p:spPr>
                <a:xfrm>
                  <a:off x="4660" y="96"/>
                  <a:ext cx="1798" cy="5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800">
                      <a:latin typeface="Arial Black" panose="020B0A04020102020204" charset="0"/>
                      <a:cs typeface="Arial Black" panose="020B0A04020102020204" charset="0"/>
                    </a:rPr>
                    <a:t> Loading system </a:t>
                  </a:r>
                  <a:endParaRPr lang="en-US" altLang="zh-CN" sz="800">
                    <a:latin typeface="Arial Black" panose="020B0A04020102020204" charset="0"/>
                    <a:cs typeface="Arial Black" panose="020B0A04020102020204" charset="0"/>
                  </a:endParaRPr>
                </a:p>
                <a:p>
                  <a:r>
                    <a:rPr lang="en-US" altLang="zh-CN" sz="800">
                      <a:latin typeface="Arial Black" panose="020B0A04020102020204" charset="0"/>
                      <a:cs typeface="Arial Black" panose="020B0A04020102020204" charset="0"/>
                    </a:rPr>
                    <a:t>     (50ug/15uL)</a:t>
                  </a:r>
                  <a:endParaRPr lang="en-US" altLang="zh-CN" sz="800">
                    <a:latin typeface="Arial Black" panose="020B0A04020102020204" charset="0"/>
                    <a:cs typeface="Arial Black" panose="020B0A04020102020204" charset="0"/>
                  </a:endParaRPr>
                </a:p>
              </p:txBody>
            </p:sp>
            <p:cxnSp>
              <p:nvCxnSpPr>
                <p:cNvPr id="28" name="直接连接符 27"/>
                <p:cNvCxnSpPr/>
                <p:nvPr/>
              </p:nvCxnSpPr>
              <p:spPr>
                <a:xfrm>
                  <a:off x="4705" y="595"/>
                  <a:ext cx="1753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组合 30"/>
              <p:cNvGrpSpPr/>
              <p:nvPr/>
            </p:nvGrpSpPr>
            <p:grpSpPr>
              <a:xfrm>
                <a:off x="6735" y="96"/>
                <a:ext cx="2054" cy="530"/>
                <a:chOff x="6735" y="96"/>
                <a:chExt cx="2054" cy="530"/>
              </a:xfrm>
            </p:grpSpPr>
            <p:sp>
              <p:nvSpPr>
                <p:cNvPr id="26" name="文本框 25"/>
                <p:cNvSpPr txBox="1"/>
                <p:nvPr/>
              </p:nvSpPr>
              <p:spPr>
                <a:xfrm>
                  <a:off x="6951" y="96"/>
                  <a:ext cx="1839" cy="5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800">
                      <a:latin typeface="Arial Black" panose="020B0A04020102020204" charset="0"/>
                      <a:cs typeface="Arial Black" panose="020B0A04020102020204" charset="0"/>
                    </a:rPr>
                    <a:t>Loading system</a:t>
                  </a:r>
                  <a:endParaRPr lang="en-US" altLang="zh-CN" sz="800">
                    <a:latin typeface="Arial Black" panose="020B0A04020102020204" charset="0"/>
                    <a:cs typeface="Arial Black" panose="020B0A04020102020204" charset="0"/>
                  </a:endParaRPr>
                </a:p>
                <a:p>
                  <a:r>
                    <a:rPr lang="en-US" altLang="zh-CN" sz="800">
                      <a:latin typeface="Arial Black" panose="020B0A04020102020204" charset="0"/>
                      <a:cs typeface="Arial Black" panose="020B0A04020102020204" charset="0"/>
                    </a:rPr>
                    <a:t>  ( 40ug/12uL)</a:t>
                  </a:r>
                  <a:endParaRPr lang="en-US" altLang="zh-CN" sz="800">
                    <a:latin typeface="Arial Black" panose="020B0A04020102020204" charset="0"/>
                    <a:cs typeface="Arial Black" panose="020B0A04020102020204" charset="0"/>
                  </a:endParaRPr>
                </a:p>
              </p:txBody>
            </p:sp>
            <p:cxnSp>
              <p:nvCxnSpPr>
                <p:cNvPr id="29" name="直接连接符 28"/>
                <p:cNvCxnSpPr/>
                <p:nvPr/>
              </p:nvCxnSpPr>
              <p:spPr>
                <a:xfrm>
                  <a:off x="6735" y="595"/>
                  <a:ext cx="1666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" name="组合 40"/>
            <p:cNvGrpSpPr/>
            <p:nvPr/>
          </p:nvGrpSpPr>
          <p:grpSpPr>
            <a:xfrm>
              <a:off x="9183" y="2114"/>
              <a:ext cx="5374" cy="2746"/>
              <a:chOff x="9936" y="2114"/>
              <a:chExt cx="5374" cy="2746"/>
            </a:xfrm>
          </p:grpSpPr>
          <p:grpSp>
            <p:nvGrpSpPr>
              <p:cNvPr id="22" name="组合 21"/>
              <p:cNvGrpSpPr/>
              <p:nvPr/>
            </p:nvGrpSpPr>
            <p:grpSpPr>
              <a:xfrm>
                <a:off x="9936" y="2783"/>
                <a:ext cx="5374" cy="2077"/>
                <a:chOff x="3675" y="2470"/>
                <a:chExt cx="5374" cy="2077"/>
              </a:xfrm>
            </p:grpSpPr>
            <p:pic>
              <p:nvPicPr>
                <p:cNvPr id="2" name="图片 1" descr="2018.6.28b-actin."/>
                <p:cNvPicPr>
                  <a:picLocks noChangeAspect="1"/>
                </p:cNvPicPr>
                <p:nvPr/>
              </p:nvPicPr>
              <p:blipFill>
                <a:blip r:embed="rId2"/>
                <a:srcRect l="31974" t="23908" r="17344" b="60679"/>
                <a:stretch>
                  <a:fillRect/>
                </a:stretch>
              </p:blipFill>
              <p:spPr>
                <a:xfrm>
                  <a:off x="3875" y="2822"/>
                  <a:ext cx="5174" cy="1725"/>
                </a:xfrm>
                <a:prstGeom prst="rect">
                  <a:avLst/>
                </a:prstGeom>
              </p:spPr>
            </p:pic>
            <p:sp>
              <p:nvSpPr>
                <p:cNvPr id="9" name="文本框 8"/>
                <p:cNvSpPr txBox="1"/>
                <p:nvPr/>
              </p:nvSpPr>
              <p:spPr>
                <a:xfrm>
                  <a:off x="3675" y="2470"/>
                  <a:ext cx="5240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>
                      <a:latin typeface="Arial Black" panose="020B0A04020102020204" charset="0"/>
                      <a:cs typeface="Arial Black" panose="020B0A04020102020204" charset="0"/>
                    </a:rPr>
                    <a:t> C        </a:t>
                  </a:r>
                  <a:r>
                    <a:rPr lang="en-US" altLang="zh-CN" sz="1000">
                      <a:latin typeface="Arial Black" panose="020B0A04020102020204" charset="0"/>
                      <a:cs typeface="Arial Black" panose="020B0A04020102020204" charset="0"/>
                    </a:rPr>
                    <a:t>24h   30h   36h    24h  30h  36h    </a:t>
                  </a:r>
                  <a:endParaRPr lang="en-US" altLang="zh-CN" sz="1000">
                    <a:latin typeface="Arial Black" panose="020B0A04020102020204" charset="0"/>
                    <a:cs typeface="Arial Black" panose="020B0A04020102020204" charset="0"/>
                  </a:endParaRPr>
                </a:p>
              </p:txBody>
            </p:sp>
          </p:grpSp>
          <p:sp>
            <p:nvSpPr>
              <p:cNvPr id="39" name="文本框 38"/>
              <p:cNvSpPr txBox="1"/>
              <p:nvPr/>
            </p:nvSpPr>
            <p:spPr>
              <a:xfrm>
                <a:off x="11642" y="2114"/>
                <a:ext cx="2071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 Loading system 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     (30ug/15uL)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</p:txBody>
          </p:sp>
          <p:cxnSp>
            <p:nvCxnSpPr>
              <p:cNvPr id="40" name="直接连接符 39"/>
              <p:cNvCxnSpPr/>
              <p:nvPr/>
            </p:nvCxnSpPr>
            <p:spPr>
              <a:xfrm>
                <a:off x="11057" y="2645"/>
                <a:ext cx="3332" cy="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" name="组合 6"/>
          <p:cNvGrpSpPr/>
          <p:nvPr/>
        </p:nvGrpSpPr>
        <p:grpSpPr>
          <a:xfrm>
            <a:off x="1507490" y="2792095"/>
            <a:ext cx="7872095" cy="2008505"/>
            <a:chOff x="3663" y="5387"/>
            <a:chExt cx="12397" cy="3163"/>
          </a:xfrm>
        </p:grpSpPr>
        <p:sp>
          <p:nvSpPr>
            <p:cNvPr id="16" name="文本框 15"/>
            <p:cNvSpPr txBox="1"/>
            <p:nvPr/>
          </p:nvSpPr>
          <p:spPr>
            <a:xfrm>
              <a:off x="14557" y="7358"/>
              <a:ext cx="150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1200">
                  <a:latin typeface="Arial Black" panose="020B0A04020102020204" charset="0"/>
                  <a:cs typeface="Arial Black" panose="020B0A04020102020204" charset="0"/>
                </a:rPr>
                <a:t>β</a:t>
              </a:r>
              <a:r>
                <a:rPr lang="en-US" altLang="zh-CN" sz="1200">
                  <a:latin typeface="Arial Black" panose="020B0A04020102020204" charset="0"/>
                  <a:cs typeface="Arial Black" panose="020B0A04020102020204" charset="0"/>
                </a:rPr>
                <a:t>-actin</a:t>
              </a:r>
              <a:endParaRPr lang="en-US" altLang="zh-CN" sz="1200">
                <a:latin typeface="Arial Black" panose="020B0A04020102020204" charset="0"/>
                <a:cs typeface="Arial Black" panose="020B0A04020102020204" charset="0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 rot="0">
              <a:off x="9264" y="6391"/>
              <a:ext cx="5293" cy="2159"/>
              <a:chOff x="3755" y="290"/>
              <a:chExt cx="5293" cy="2159"/>
            </a:xfrm>
          </p:grpSpPr>
          <p:pic>
            <p:nvPicPr>
              <p:cNvPr id="15" name="图片 14" descr="CXQ2018.5.18B-ACT"/>
              <p:cNvPicPr>
                <a:picLocks noChangeAspect="1"/>
              </p:cNvPicPr>
              <p:nvPr/>
            </p:nvPicPr>
            <p:blipFill>
              <a:blip r:embed="rId3">
                <a:lum bright="-6000"/>
              </a:blip>
              <a:srcRect l="20648" t="35814" r="29531" b="42746"/>
              <a:stretch>
                <a:fillRect/>
              </a:stretch>
            </p:blipFill>
            <p:spPr>
              <a:xfrm>
                <a:off x="3874" y="595"/>
                <a:ext cx="5174" cy="1854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3755" y="290"/>
                <a:ext cx="464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>
                    <a:latin typeface="Arial Black" panose="020B0A04020102020204" charset="0"/>
                    <a:cs typeface="Arial Black" panose="020B0A04020102020204" charset="0"/>
                  </a:rPr>
                  <a:t>D        </a:t>
                </a:r>
                <a:r>
                  <a:rPr lang="en-US" altLang="zh-CN" sz="1000">
                    <a:latin typeface="Arial Black" panose="020B0A04020102020204" charset="0"/>
                    <a:cs typeface="Arial Black" panose="020B0A04020102020204" charset="0"/>
                    <a:sym typeface="+mn-ea"/>
                  </a:rPr>
                  <a:t>24h   30h   36h   24h   30h   36h   </a:t>
                </a:r>
                <a:endParaRPr lang="en-US" altLang="zh-CN" sz="1000">
                  <a:latin typeface="Arial Black" panose="020B0A04020102020204" charset="0"/>
                  <a:cs typeface="Arial Black" panose="020B0A04020102020204" charset="0"/>
                </a:endParaRPr>
              </a:p>
            </p:txBody>
          </p:sp>
        </p:grpSp>
        <p:grpSp>
          <p:nvGrpSpPr>
            <p:cNvPr id="37" name="组合 36"/>
            <p:cNvGrpSpPr/>
            <p:nvPr/>
          </p:nvGrpSpPr>
          <p:grpSpPr>
            <a:xfrm>
              <a:off x="3663" y="5387"/>
              <a:ext cx="5278" cy="3162"/>
              <a:chOff x="3665" y="4264"/>
              <a:chExt cx="5278" cy="3162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3665" y="4902"/>
                <a:ext cx="5278" cy="2524"/>
                <a:chOff x="4657" y="5099"/>
                <a:chExt cx="4285" cy="1934"/>
              </a:xfrm>
            </p:grpSpPr>
            <p:pic>
              <p:nvPicPr>
                <p:cNvPr id="19" name="图片 19" descr="2018,7,2mtor"/>
                <p:cNvPicPr>
                  <a:picLocks noChangeAspect="1"/>
                </p:cNvPicPr>
                <p:nvPr/>
              </p:nvPicPr>
              <p:blipFill>
                <a:blip r:embed="rId4">
                  <a:lum bright="18000" contrast="42000"/>
                </a:blip>
                <a:srcRect l="33243" t="37005" r="11125" b="40992"/>
                <a:stretch>
                  <a:fillRect/>
                </a:stretch>
              </p:blipFill>
              <p:spPr>
                <a:xfrm rot="10800000">
                  <a:off x="4742" y="5330"/>
                  <a:ext cx="4200" cy="1703"/>
                </a:xfrm>
                <a:prstGeom prst="rect">
                  <a:avLst/>
                </a:prstGeom>
              </p:spPr>
            </p:pic>
            <p:sp>
              <p:nvSpPr>
                <p:cNvPr id="11" name="文本框 10"/>
                <p:cNvSpPr txBox="1"/>
                <p:nvPr/>
              </p:nvSpPr>
              <p:spPr>
                <a:xfrm>
                  <a:off x="4657" y="5099"/>
                  <a:ext cx="4076" cy="3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>
                      <a:latin typeface="Arial Black" panose="020B0A04020102020204" charset="0"/>
                      <a:cs typeface="Arial Black" panose="020B0A04020102020204" charset="0"/>
                    </a:rPr>
                    <a:t>B          </a:t>
                  </a:r>
                  <a:r>
                    <a:rPr lang="en-US" altLang="zh-CN" sz="1000">
                      <a:latin typeface="Arial Black" panose="020B0A04020102020204" charset="0"/>
                      <a:cs typeface="Arial Black" panose="020B0A04020102020204" charset="0"/>
                    </a:rPr>
                    <a:t> </a:t>
                  </a:r>
                  <a:r>
                    <a:rPr lang="en-US" altLang="zh-CN" sz="1000">
                      <a:latin typeface="Arial Black" panose="020B0A04020102020204" charset="0"/>
                      <a:cs typeface="Arial Black" panose="020B0A04020102020204" charset="0"/>
                      <a:sym typeface="+mn-ea"/>
                    </a:rPr>
                    <a:t>24h    30h   36h   24h   30h   36h   </a:t>
                  </a:r>
                  <a:endParaRPr lang="en-US" altLang="zh-CN" sz="1000">
                    <a:latin typeface="Arial Black" panose="020B0A04020102020204" charset="0"/>
                    <a:cs typeface="Arial Black" panose="020B0A04020102020204" charset="0"/>
                  </a:endParaRPr>
                </a:p>
              </p:txBody>
            </p:sp>
          </p:grpSp>
          <p:sp>
            <p:nvSpPr>
              <p:cNvPr id="33" name="文本框 32"/>
              <p:cNvSpPr txBox="1"/>
              <p:nvPr/>
            </p:nvSpPr>
            <p:spPr>
              <a:xfrm>
                <a:off x="4705" y="4264"/>
                <a:ext cx="1798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 Loading system 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     (50ug/15uL)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</p:txBody>
          </p:sp>
          <p:cxnSp>
            <p:nvCxnSpPr>
              <p:cNvPr id="34" name="直接连接符 33"/>
              <p:cNvCxnSpPr/>
              <p:nvPr/>
            </p:nvCxnSpPr>
            <p:spPr>
              <a:xfrm>
                <a:off x="4705" y="4795"/>
                <a:ext cx="175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6648" y="4264"/>
                <a:ext cx="1839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Loading system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  <a:p>
                <a:r>
                  <a:rPr lang="en-US" altLang="zh-CN" sz="800">
                    <a:latin typeface="Arial Black" panose="020B0A04020102020204" charset="0"/>
                    <a:cs typeface="Arial Black" panose="020B0A04020102020204" charset="0"/>
                  </a:rPr>
                  <a:t>  ( 40ug/12uL)</a:t>
                </a:r>
                <a:endParaRPr lang="en-US" altLang="zh-CN" sz="800">
                  <a:latin typeface="Arial Black" panose="020B0A04020102020204" charset="0"/>
                  <a:cs typeface="Arial Black" panose="020B0A04020102020204" charset="0"/>
                </a:endParaRPr>
              </a:p>
            </p:txBody>
          </p:sp>
          <p:cxnSp>
            <p:nvCxnSpPr>
              <p:cNvPr id="36" name="直接连接符 35"/>
              <p:cNvCxnSpPr/>
              <p:nvPr/>
            </p:nvCxnSpPr>
            <p:spPr>
              <a:xfrm>
                <a:off x="6691" y="4795"/>
                <a:ext cx="175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文本框 41"/>
            <p:cNvSpPr txBox="1"/>
            <p:nvPr/>
          </p:nvSpPr>
          <p:spPr>
            <a:xfrm>
              <a:off x="10934" y="5494"/>
              <a:ext cx="2071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Black" panose="020B0A04020102020204" charset="0"/>
                  <a:cs typeface="Arial Black" panose="020B0A04020102020204" charset="0"/>
                </a:rPr>
                <a:t> Loading system </a:t>
              </a:r>
              <a:endParaRPr lang="en-US" altLang="zh-CN" sz="800">
                <a:latin typeface="Arial Black" panose="020B0A04020102020204" charset="0"/>
                <a:cs typeface="Arial Black" panose="020B0A04020102020204" charset="0"/>
              </a:endParaRPr>
            </a:p>
            <a:p>
              <a:r>
                <a:rPr lang="en-US" altLang="zh-CN" sz="800">
                  <a:latin typeface="Arial Black" panose="020B0A04020102020204" charset="0"/>
                  <a:cs typeface="Arial Black" panose="020B0A04020102020204" charset="0"/>
                </a:rPr>
                <a:t>    </a:t>
              </a:r>
              <a:r>
                <a:rPr lang="en-US" altLang="zh-CN" sz="800" b="1">
                  <a:latin typeface="Arial Black" panose="020B0A04020102020204" charset="0"/>
                  <a:cs typeface="Arial Black" panose="020B0A04020102020204" charset="0"/>
                </a:rPr>
                <a:t>（ </a:t>
              </a:r>
              <a:r>
                <a:rPr lang="en-US" altLang="zh-CN" sz="800">
                  <a:latin typeface="Arial Black" panose="020B0A04020102020204" charset="0"/>
                  <a:cs typeface="Arial Black" panose="020B0A04020102020204" charset="0"/>
                </a:rPr>
                <a:t>30ug/15uL)</a:t>
              </a:r>
              <a:endParaRPr lang="en-US" altLang="zh-CN" sz="800">
                <a:latin typeface="Arial Black" panose="020B0A04020102020204" charset="0"/>
                <a:cs typeface="Arial Black" panose="020B0A04020102020204" charset="0"/>
              </a:endParaRPr>
            </a:p>
          </p:txBody>
        </p:sp>
        <p:cxnSp>
          <p:nvCxnSpPr>
            <p:cNvPr id="49" name="直接连接符 48"/>
            <p:cNvCxnSpPr/>
            <p:nvPr/>
          </p:nvCxnSpPr>
          <p:spPr>
            <a:xfrm flipV="1">
              <a:off x="10432" y="6025"/>
              <a:ext cx="3077" cy="3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84</Words>
  <Application>WPS 演示</Application>
  <PresentationFormat>全屏显示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Arial Black</vt:lpstr>
      <vt:lpstr>Times New Roman</vt:lpstr>
      <vt:lpstr>Office 主题​​</vt:lpstr>
      <vt:lpstr>PowerPoint 演示文稿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ljl</cp:lastModifiedBy>
  <cp:revision>16</cp:revision>
  <dcterms:created xsi:type="dcterms:W3CDTF">2019-07-17T14:46:00Z</dcterms:created>
  <dcterms:modified xsi:type="dcterms:W3CDTF">2020-05-22T13:47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208</vt:lpwstr>
  </property>
</Properties>
</file>